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B159D7-7325-4A5F-A392-C207C7C0F4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7FE633-5F5B-4DDC-9E6D-31B06505CB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AD041-C148-4EF0-B2AE-33054522AC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F9B5A2-90A5-490B-9ADE-D13005CA1F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72AED-860C-424E-AB3F-B2396F99D0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AD897-A15F-4BA3-9565-A78977C94F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4535E-0995-4E3B-98BB-F99AF313C5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081EB-691C-4690-A96C-72A23725C8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8E999-1BD9-48C0-A293-E39CF554F9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8C25A-A2E0-41ED-8CB3-E177B5111A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10597-A8B1-4FCF-9E06-7AB5D0ABE3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417950-BDE5-441B-8236-25CA92307C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F9BB37-E923-4BAF-B4E6-97CAFABD397B}" type="slidenum">
              <a:rPr b="0" lang="el-G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928800" y="428760"/>
            <a:ext cx="2857320" cy="8190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SPERM PREPAR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(IVF Preparation Technique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SAMPLE 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(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Undetermined Function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CONTROL (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Fertile Donors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928800" y="2046240"/>
            <a:ext cx="2857320" cy="6429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CONTROL AND SAMPLE DROPLE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with fixed sperm concentr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928800" y="3747960"/>
            <a:ext cx="2857320" cy="6429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CO-INCUB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of processed sperm with hamster ov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928800" y="5248440"/>
            <a:ext cx="2857320" cy="642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MICROSCOP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8"/>
          <p:cNvSpPr/>
          <p:nvPr/>
        </p:nvSpPr>
        <p:spPr>
          <a:xfrm>
            <a:off x="2365200" y="1255680"/>
            <a:ext cx="0" cy="773280"/>
          </a:xfrm>
          <a:prstGeom prst="line">
            <a:avLst/>
          </a:prstGeom>
          <a:ln w="25560">
            <a:solidFill>
              <a:srgbClr val="b6dcd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10"/>
          <p:cNvSpPr/>
          <p:nvPr/>
        </p:nvSpPr>
        <p:spPr>
          <a:xfrm>
            <a:off x="2357280" y="2701800"/>
            <a:ext cx="0" cy="1025640"/>
          </a:xfrm>
          <a:prstGeom prst="line">
            <a:avLst/>
          </a:prstGeom>
          <a:ln w="25560">
            <a:solidFill>
              <a:srgbClr val="b6dcd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14"/>
          <p:cNvSpPr/>
          <p:nvPr/>
        </p:nvSpPr>
        <p:spPr>
          <a:xfrm>
            <a:off x="2357280" y="4403880"/>
            <a:ext cx="0" cy="823680"/>
          </a:xfrm>
          <a:prstGeom prst="line">
            <a:avLst/>
          </a:prstGeom>
          <a:ln w="25560">
            <a:solidFill>
              <a:srgbClr val="b6dcd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5"/>
          <p:cNvSpPr/>
          <p:nvPr/>
        </p:nvSpPr>
        <p:spPr>
          <a:xfrm>
            <a:off x="2835360" y="2921040"/>
            <a:ext cx="2857320" cy="64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HAMSTER SUPEROVULATION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Chemically Removed Zona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2"/>
          <p:cNvSpPr/>
          <p:nvPr/>
        </p:nvSpPr>
        <p:spPr>
          <a:xfrm>
            <a:off x="4079880" y="5248440"/>
            <a:ext cx="2857320" cy="642600"/>
          </a:xfrm>
          <a:prstGeom prst="rect">
            <a:avLst/>
          </a:prstGeom>
          <a:solidFill>
            <a:srgbClr val="3c8c9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Penetration Rat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[</a:t>
            </a:r>
            <a:r>
              <a:rPr b="0" lang="el-GR" sz="1000" spc="-1" strike="noStrike">
                <a:solidFill>
                  <a:srgbClr val="000000"/>
                </a:solidFill>
                <a:latin typeface="Palatino Linotype"/>
              </a:rPr>
              <a:t>No 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of  Ova with Positive Penetration/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Total No of Ova ]  x 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24"/>
          <p:cNvSpPr/>
          <p:nvPr/>
        </p:nvSpPr>
        <p:spPr>
          <a:xfrm flipH="1">
            <a:off x="3786120" y="5568120"/>
            <a:ext cx="293760" cy="1800"/>
          </a:xfrm>
          <a:prstGeom prst="line">
            <a:avLst/>
          </a:prstGeom>
          <a:ln w="25560">
            <a:solidFill>
              <a:srgbClr val="b6dcd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eft Arrow 13"/>
          <p:cNvSpPr/>
          <p:nvPr/>
        </p:nvSpPr>
        <p:spPr>
          <a:xfrm>
            <a:off x="2786040" y="3125880"/>
            <a:ext cx="357120" cy="214200"/>
          </a:xfrm>
          <a:prstGeom prst="leftArrow">
            <a:avLst>
              <a:gd name="adj1" fmla="val 50000"/>
              <a:gd name="adj2" fmla="val 50017"/>
            </a:avLst>
          </a:prstGeom>
          <a:solidFill>
            <a:srgbClr val="cccc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18T04:55:15Z</dcterms:created>
  <dc:creator>user</dc:creator>
  <dc:description/>
  <dc:language>en-US</dc:language>
  <cp:lastModifiedBy>Admin</cp:lastModifiedBy>
  <dcterms:modified xsi:type="dcterms:W3CDTF">2013-02-09T20:11:50Z</dcterms:modified>
  <cp:revision>38</cp:revision>
  <dc:subject/>
  <dc:title>Διαφάνεια 1</dc:title>
</cp:coreProperties>
</file>